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0D9FC-EA01-45F4-949E-05529BA162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6D986-69DF-4D0F-8425-BEC7AAF80F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5FB2F-6D2B-42C3-B4AE-8C9FC615B6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499E5-99EB-42AE-98E2-08D07E3EC1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5A8944-F9A3-4A8F-A645-C8474310E7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35A32-F522-42E6-BF18-B7F7F732DA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7EE4B-6221-4E9F-8A78-CFDBAF7230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5D3A1-C6AE-4332-A306-78B3B1F3BF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4081C-F1DF-4B13-95E4-538A5CC5E9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E99B0-ABAF-4E71-9B3C-281588DD44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73C2F-1F35-4ECC-9C58-D38AA0829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3AE4E-A303-46F8-9D6B-692E4AB211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D3037B-EAD7-4926-A722-3DA10893756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643280" y="2135160"/>
          <a:ext cx="3970440" cy="2206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643280" y="2135160"/>
                    <a:ext cx="3970440" cy="2206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324000" y="2133720"/>
          <a:ext cx="4167000" cy="22082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4000" y="2133720"/>
                    <a:ext cx="4167000" cy="2208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380520" y="1060560"/>
            <a:ext cx="67554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Additional file 1 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 D1 on neuroblastoma and melanoma cell proliferation analyzed with drug washout experiments.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03120" y="4365720"/>
            <a:ext cx="8229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Legen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Drug washout assays to assess the impact of D1 time exposure on cell proliferation in neuroblastoma cells (</a:t>
            </a: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) and melanoma cells (</a:t>
            </a: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). Cells were incubated with D1 for the indicated times and concentration and then washed and cultured in drug-free medium up to 72 hours. Cell proliferation was assessed by 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3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H-thymidine incorporation. Results, derived from three different experiments, are expressed as mean percentage of 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3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H-thymidine incorporation from quadruplicate wells as compared to control cells. Error bars represent 95% confidence interva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97080" y="18446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686480" y="18604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08T14:35:43Z</dcterms:created>
  <dc:creator>ponzoni</dc:creator>
  <dc:description/>
  <dc:language>en-US</dc:language>
  <cp:lastModifiedBy>C.N.R</cp:lastModifiedBy>
  <dcterms:modified xsi:type="dcterms:W3CDTF">2010-05-28T15:19:37Z</dcterms:modified>
  <cp:revision>10</cp:revision>
  <dc:subject/>
  <dc:title>Diapositiva 1</dc:title>
</cp:coreProperties>
</file>